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056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36229-1BF4-4300-8EFD-C4A7DD89CF02}" type="datetimeFigureOut">
              <a:rPr lang="en-US" smtClean="0"/>
              <a:pPr/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68CBB6-9C14-4D1A-95E9-9D9B19A86A11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G:\Jamsheer 2003\Backup from lap\Jamsheer\work\Papers\Phylogentic analysis\Final analysis\Phylogenetic analysis of individual species\Arabidopsis\Gene structure\Splice variants.pn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62000" y="2971800"/>
            <a:ext cx="5486400" cy="712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3" descr="G:\Jamsheer 2003\Backup from lap\Jamsheer\work\Papers\Phylogentic analysis\Final analysis\Phylogenetic analysis of individual species\Arabidopsis\Gene structure\Gene structure final.pn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762000" y="381000"/>
            <a:ext cx="5486400" cy="2468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4" descr="G:\Jamsheer 2003\Backup from lap\Jamsheer\work\Papers\Phylogentic analysis\Final analysis\Phylogenetic analysis of individual species\Arabidopsis\protein structure\PROTEIN STRUCTURE.png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762000" y="3810000"/>
            <a:ext cx="5486400" cy="2578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6"/>
          <p:cNvSpPr txBox="1">
            <a:spLocks noChangeArrowheads="1"/>
          </p:cNvSpPr>
          <p:nvPr/>
        </p:nvSpPr>
        <p:spPr bwMode="auto">
          <a:xfrm>
            <a:off x="609600" y="409575"/>
            <a:ext cx="277813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>
                <a:latin typeface="Calibri" pitchFamily="34" charset="0"/>
              </a:rPr>
              <a:t>A</a:t>
            </a:r>
          </a:p>
        </p:txBody>
      </p:sp>
      <p:sp>
        <p:nvSpPr>
          <p:cNvPr id="6" name="TextBox 7"/>
          <p:cNvSpPr txBox="1">
            <a:spLocks noChangeArrowheads="1"/>
          </p:cNvSpPr>
          <p:nvPr/>
        </p:nvSpPr>
        <p:spPr bwMode="auto">
          <a:xfrm>
            <a:off x="566738" y="2819400"/>
            <a:ext cx="271462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>
                <a:latin typeface="Calibri" pitchFamily="34" charset="0"/>
              </a:rPr>
              <a:t>B</a:t>
            </a:r>
          </a:p>
        </p:txBody>
      </p:sp>
      <p:sp>
        <p:nvSpPr>
          <p:cNvPr id="7" name="TextBox 8"/>
          <p:cNvSpPr txBox="1">
            <a:spLocks noChangeArrowheads="1"/>
          </p:cNvSpPr>
          <p:nvPr/>
        </p:nvSpPr>
        <p:spPr bwMode="auto">
          <a:xfrm>
            <a:off x="585788" y="3581400"/>
            <a:ext cx="2667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b="1" dirty="0">
                <a:latin typeface="Calibri" pitchFamily="34" charset="0"/>
              </a:rPr>
              <a:t>C</a:t>
            </a:r>
          </a:p>
        </p:txBody>
      </p:sp>
      <p:sp>
        <p:nvSpPr>
          <p:cNvPr id="8" name="Rectangle 9"/>
          <p:cNvSpPr>
            <a:spLocks noChangeArrowheads="1"/>
          </p:cNvSpPr>
          <p:nvPr/>
        </p:nvSpPr>
        <p:spPr bwMode="auto">
          <a:xfrm>
            <a:off x="457200" y="6629400"/>
            <a:ext cx="5867400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5 Fig.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Gene structure, splice variants and domain organization of </a:t>
            </a:r>
            <a:r>
              <a:rPr lang="en-US" sz="1200" b="1" i="1" dirty="0">
                <a:latin typeface="Times New Roman" pitchFamily="18" charset="0"/>
                <a:cs typeface="Times New Roman" pitchFamily="18" charset="0"/>
              </a:rPr>
              <a:t>Arabidopsis thaliana FLZ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 family.</a:t>
            </a:r>
          </a:p>
          <a:p>
            <a:pPr algn="just"/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(A) Gene structure of 18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. thaliana FLZ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genes showing exon, intron and UTR organization. (B) Alternative transcripts of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. thaliana FLZ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genes .(C) Domain organization of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. thalian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FLZ proteins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.A Laxmi-203</dc:creator>
  <cp:lastModifiedBy>Dr.A Laxmi-203</cp:lastModifiedBy>
  <cp:revision>2</cp:revision>
  <dcterms:created xsi:type="dcterms:W3CDTF">2015-07-04T15:00:14Z</dcterms:created>
  <dcterms:modified xsi:type="dcterms:W3CDTF">2015-07-16T11:21:33Z</dcterms:modified>
</cp:coreProperties>
</file>